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0" autoAdjust="0"/>
    <p:restoredTop sz="94660"/>
  </p:normalViewPr>
  <p:slideViewPr>
    <p:cSldViewPr snapToGrid="0">
      <p:cViewPr varScale="1">
        <p:scale>
          <a:sx n="40" d="100"/>
          <a:sy n="40" d="100"/>
        </p:scale>
        <p:origin x="227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192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639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36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840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208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8936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006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6205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8346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4531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0322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2201B-ABBE-4C2F-A26D-841FD79A34FF}" type="datetimeFigureOut">
              <a:rPr lang="en-GB" smtClean="0"/>
              <a:t>1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E4AFC-065B-4D63-8721-0D7AF880F4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850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4056" y="2306439"/>
            <a:ext cx="10099844" cy="4210475"/>
          </a:xfrm>
          <a:prstGeom prst="rect">
            <a:avLst/>
          </a:prstGeom>
        </p:spPr>
      </p:pic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7994510"/>
              </p:ext>
            </p:extLst>
          </p:nvPr>
        </p:nvGraphicFramePr>
        <p:xfrm>
          <a:off x="1602777" y="6358501"/>
          <a:ext cx="9042401" cy="4773956"/>
        </p:xfrm>
        <a:graphic>
          <a:graphicData uri="http://schemas.openxmlformats.org/drawingml/2006/table">
            <a:tbl>
              <a:tblPr/>
              <a:tblGrid>
                <a:gridCol w="720689">
                  <a:extLst>
                    <a:ext uri="{9D8B030D-6E8A-4147-A177-3AD203B41FA5}">
                      <a16:colId xmlns:a16="http://schemas.microsoft.com/office/drawing/2014/main" val="1206287010"/>
                    </a:ext>
                  </a:extLst>
                </a:gridCol>
                <a:gridCol w="5255027">
                  <a:extLst>
                    <a:ext uri="{9D8B030D-6E8A-4147-A177-3AD203B41FA5}">
                      <a16:colId xmlns:a16="http://schemas.microsoft.com/office/drawing/2014/main" val="3240527344"/>
                    </a:ext>
                  </a:extLst>
                </a:gridCol>
                <a:gridCol w="1681609">
                  <a:extLst>
                    <a:ext uri="{9D8B030D-6E8A-4147-A177-3AD203B41FA5}">
                      <a16:colId xmlns:a16="http://schemas.microsoft.com/office/drawing/2014/main" val="550321263"/>
                    </a:ext>
                  </a:extLst>
                </a:gridCol>
                <a:gridCol w="1385076">
                  <a:extLst>
                    <a:ext uri="{9D8B030D-6E8A-4147-A177-3AD203B41FA5}">
                      <a16:colId xmlns:a16="http://schemas.microsoft.com/office/drawing/2014/main" val="1090235156"/>
                    </a:ext>
                  </a:extLst>
                </a:gridCol>
              </a:tblGrid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r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_na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_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_p_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0972323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 interferon receptor bind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1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6675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6560697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 ac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2758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4406189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vement of cell or subcellular compon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69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4670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352159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omo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400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4380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5654938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 regulation of cell proliferation involved in heart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20001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9805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7671064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body fib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708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3311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979686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tion of IFNA signal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:R-GGA-9126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0615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7968115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-4; motif: NTTTCSCGCC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7380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446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364776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NGGGGGCGGGGY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196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1259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9348926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GGGGCGGGGT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008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141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128503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; motif: GGCGSG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803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7496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3770744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; motif: GGCGS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8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9355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068250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NGGGGGCGGGGY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1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8351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9894375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-4; motif: NTTTCSCG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73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6333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4945166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AP2; motif: GCCYGSGGS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8867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9510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231823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-1; motif: TTGGCGCGRAANNGN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9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9431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7305713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NGGGGCGGGG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73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7610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914212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GGGGCGGGGC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931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7797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2660396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NNGGGGCGGGGN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932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93805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713088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-1; motif: NNNSSCGCSAAN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72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6968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4342867"/>
                  </a:ext>
                </a:extLst>
              </a:tr>
              <a:tr h="2169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p1; motif: NGGGGCGGGG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7395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7711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992664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291771" y="1088571"/>
            <a:ext cx="2308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le </a:t>
            </a:r>
            <a:r>
              <a:rPr lang="en-US" altLang="zh-CN" b="1" dirty="0"/>
              <a:t>S</a:t>
            </a:r>
            <a:r>
              <a:rPr lang="en-GB" b="1" dirty="0"/>
              <a:t>7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602777" y="11277600"/>
            <a:ext cx="2675732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GO:MF – Gene ontology molecular function</a:t>
            </a:r>
          </a:p>
          <a:p>
            <a:r>
              <a:rPr lang="en-GB" sz="1100" dirty="0"/>
              <a:t>GO:BP – Gene ontology Biological process</a:t>
            </a:r>
          </a:p>
          <a:p>
            <a:r>
              <a:rPr lang="en-GB" sz="1100" dirty="0"/>
              <a:t>GO:CC – Gene ontology cellular component</a:t>
            </a:r>
          </a:p>
          <a:p>
            <a:r>
              <a:rPr lang="en-GB" sz="1100" dirty="0"/>
              <a:t>REAC – </a:t>
            </a:r>
            <a:r>
              <a:rPr lang="en-GB" sz="1100" dirty="0" err="1"/>
              <a:t>Reactome</a:t>
            </a:r>
            <a:endParaRPr lang="en-GB" sz="1100" dirty="0"/>
          </a:p>
          <a:p>
            <a:r>
              <a:rPr lang="en-GB" sz="1100" dirty="0"/>
              <a:t>TF – Transcription factor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286994" y="1791964"/>
            <a:ext cx="110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. Line 6</a:t>
            </a:r>
            <a:r>
              <a:rPr lang="en-GB" baseline="-25000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600491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91771" y="1088571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. Line 7</a:t>
            </a:r>
            <a:r>
              <a:rPr lang="en-GB" baseline="-25000" dirty="0"/>
              <a:t>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474107" y="14161987"/>
            <a:ext cx="2675732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GO:MF – Gene ontology molecular function</a:t>
            </a:r>
          </a:p>
          <a:p>
            <a:r>
              <a:rPr lang="en-GB" sz="1100" dirty="0"/>
              <a:t>GO:BP – Gene ontology Biological process</a:t>
            </a:r>
          </a:p>
          <a:p>
            <a:r>
              <a:rPr lang="en-GB" sz="1100" dirty="0"/>
              <a:t>GO:CC – Gene ontology cellular component</a:t>
            </a:r>
          </a:p>
          <a:p>
            <a:r>
              <a:rPr lang="en-GB" sz="1100" dirty="0"/>
              <a:t>KEGG – KEGG pathway</a:t>
            </a:r>
          </a:p>
          <a:p>
            <a:r>
              <a:rPr lang="en-GB" sz="1100" dirty="0"/>
              <a:t>REAC – </a:t>
            </a:r>
            <a:r>
              <a:rPr lang="en-GB" sz="1100" dirty="0" err="1"/>
              <a:t>Reactome</a:t>
            </a:r>
            <a:endParaRPr lang="en-GB" sz="1100" dirty="0"/>
          </a:p>
          <a:p>
            <a:r>
              <a:rPr lang="en-GB" sz="1100" dirty="0"/>
              <a:t>TF – Transcription factor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430" y="2085425"/>
            <a:ext cx="10551886" cy="3303344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5834841"/>
              </p:ext>
            </p:extLst>
          </p:nvPr>
        </p:nvGraphicFramePr>
        <p:xfrm>
          <a:off x="1474107" y="5747671"/>
          <a:ext cx="9179379" cy="8157014"/>
        </p:xfrm>
        <a:graphic>
          <a:graphicData uri="http://schemas.openxmlformats.org/drawingml/2006/table">
            <a:tbl>
              <a:tblPr/>
              <a:tblGrid>
                <a:gridCol w="785051">
                  <a:extLst>
                    <a:ext uri="{9D8B030D-6E8A-4147-A177-3AD203B41FA5}">
                      <a16:colId xmlns:a16="http://schemas.microsoft.com/office/drawing/2014/main" val="3101508646"/>
                    </a:ext>
                  </a:extLst>
                </a:gridCol>
                <a:gridCol w="4775731">
                  <a:extLst>
                    <a:ext uri="{9D8B030D-6E8A-4147-A177-3AD203B41FA5}">
                      <a16:colId xmlns:a16="http://schemas.microsoft.com/office/drawing/2014/main" val="2688856824"/>
                    </a:ext>
                  </a:extLst>
                </a:gridCol>
                <a:gridCol w="2011695">
                  <a:extLst>
                    <a:ext uri="{9D8B030D-6E8A-4147-A177-3AD203B41FA5}">
                      <a16:colId xmlns:a16="http://schemas.microsoft.com/office/drawing/2014/main" val="745692603"/>
                    </a:ext>
                  </a:extLst>
                </a:gridCol>
                <a:gridCol w="1606902">
                  <a:extLst>
                    <a:ext uri="{9D8B030D-6E8A-4147-A177-3AD203B41FA5}">
                      <a16:colId xmlns:a16="http://schemas.microsoft.com/office/drawing/2014/main" val="1961143292"/>
                    </a:ext>
                  </a:extLst>
                </a:gridCol>
              </a:tblGrid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r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_na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_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_p_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9016657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 ac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950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79082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 interferon receptor bind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1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456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67825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 receptor bind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1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442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853958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eptor ligand ac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480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5704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1487745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aling receptor activator ac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305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7774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578568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M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membrane-ephrin receptor activ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0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80968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1096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be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352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224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6994408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 vessel developm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15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380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86261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ory system developm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723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9685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196406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sculature developm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19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963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71546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 vessel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485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2855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52076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keletal muscle satellite cell differenti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148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2600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4667256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tomical structure formation involved in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486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4977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06461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be developm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352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3117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68824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ermal placode developm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716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5223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635832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ermal placode form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607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5223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0038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ermal placode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716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5223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169355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flow tract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31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7197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808491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 to ds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433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9657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50655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ntricular septum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604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2719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2324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diac septum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604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8563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6874044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tomical structure morphogene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96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9148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43489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-cell junc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:00059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73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011559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-cytokine receptor interac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0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3403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062266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luenza 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51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5728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104508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solic DNA-sens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6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0271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4684902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G-I-like receptor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6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3819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58055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ll-like receptor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6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5468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93430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cropto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2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0103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571079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D-like receptor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46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1208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9984418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rpes simplex virus 1 infec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:051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2802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208722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tion of IFNA signal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:R-GGA-9126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2596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1678000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feron Signal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:R-GGA-9135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6285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39771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feron alpha/beta signal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AC:R-GGA-9097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5539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029556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IRF4; motif: MNNRAAANGA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88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0544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6719503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IRF-3; motif: NBNBTTTCSCT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12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5018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1096252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IRF-8; motif: AGTTTCW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1665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6392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181121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IRF; motif: NNGAAANTGAAAN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8887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2939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4303226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NF-kappaB; motif: NGGGANTTYCCMNNN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7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6358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6153909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IRF; motif: NNGAAANTGAAAN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88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7011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188012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E2F-1; motif: TWSGCGCGAAAAYK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00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94473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3050195"/>
                  </a:ext>
                </a:extLst>
              </a:tr>
              <a:tr h="189698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: Sox-9; motif: RNACAAAGGVN; match class: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:M01284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206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47436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4307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823</Words>
  <Application>Microsoft Office PowerPoint</Application>
  <PresentationFormat>Custom</PresentationFormat>
  <Paragraphs>27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queline Smith</dc:creator>
  <cp:lastModifiedBy>MDPI</cp:lastModifiedBy>
  <cp:revision>5</cp:revision>
  <dcterms:created xsi:type="dcterms:W3CDTF">2022-08-24T12:57:29Z</dcterms:created>
  <dcterms:modified xsi:type="dcterms:W3CDTF">2022-11-13T09:43:12Z</dcterms:modified>
</cp:coreProperties>
</file>